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90" d="100"/>
          <a:sy n="90" d="100"/>
        </p:scale>
        <p:origin x="-642" y="-1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1" i="1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 sz="1200" dirty="0" smtClean="0"/>
              <a:t>FAT1</a:t>
            </a:r>
            <a:endParaRPr lang="en-US" sz="1200" dirty="0"/>
          </a:p>
        </c:rich>
      </c:tx>
      <c:layout>
        <c:manualLayout>
          <c:xMode val="edge"/>
          <c:yMode val="edge"/>
          <c:x val="0.46481876332622601"/>
          <c:y val="2.0172910662824207E-2"/>
        </c:manualLayout>
      </c:layout>
      <c:overlay val="0"/>
      <c:spPr>
        <a:noFill/>
        <a:ln w="25454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4712153518123666"/>
          <c:y val="0.11239193083573487"/>
          <c:w val="0.84008528784648184"/>
          <c:h val="0.5302593659942362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999FF"/>
            </a:solidFill>
            <a:ln w="25454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008000"/>
              </a:solidFill>
              <a:ln w="25454">
                <a:noFill/>
              </a:ln>
            </c:spPr>
          </c:dPt>
          <c:dPt>
            <c:idx val="1"/>
            <c:invertIfNegative val="0"/>
            <c:bubble3D val="0"/>
            <c:spPr>
              <a:solidFill>
                <a:srgbClr val="008000"/>
              </a:solidFill>
              <a:ln w="25454">
                <a:noFill/>
              </a:ln>
            </c:spPr>
          </c:dPt>
          <c:dPt>
            <c:idx val="2"/>
            <c:invertIfNegative val="0"/>
            <c:bubble3D val="0"/>
            <c:spPr>
              <a:solidFill>
                <a:srgbClr val="008000"/>
              </a:solidFill>
              <a:ln w="25454">
                <a:noFill/>
              </a:ln>
            </c:spPr>
          </c:dPt>
          <c:dPt>
            <c:idx val="3"/>
            <c:invertIfNegative val="0"/>
            <c:bubble3D val="0"/>
            <c:spPr>
              <a:solidFill>
                <a:srgbClr val="008000"/>
              </a:solidFill>
              <a:ln w="25454">
                <a:noFill/>
              </a:ln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  <a:ln w="25454">
                <a:noFill/>
              </a:ln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 w="25454">
                <a:noFill/>
              </a:ln>
            </c:spPr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 w="25454">
                <a:noFill/>
              </a:ln>
            </c:spPr>
          </c:dPt>
          <c:dPt>
            <c:idx val="7"/>
            <c:invertIfNegative val="0"/>
            <c:bubble3D val="0"/>
            <c:spPr>
              <a:solidFill>
                <a:srgbClr val="0000FF"/>
              </a:solidFill>
              <a:ln w="25454">
                <a:noFill/>
              </a:ln>
            </c:spPr>
          </c:dPt>
          <c:dPt>
            <c:idx val="8"/>
            <c:invertIfNegative val="0"/>
            <c:bubble3D val="0"/>
            <c:spPr>
              <a:solidFill>
                <a:srgbClr val="0000FF"/>
              </a:solidFill>
              <a:ln w="25454">
                <a:noFill/>
              </a:ln>
            </c:spPr>
          </c:dPt>
          <c:dPt>
            <c:idx val="9"/>
            <c:invertIfNegative val="0"/>
            <c:bubble3D val="0"/>
            <c:spPr>
              <a:solidFill>
                <a:srgbClr val="0000FF"/>
              </a:solidFill>
              <a:ln w="25454">
                <a:noFill/>
              </a:ln>
            </c:spPr>
          </c:dPt>
          <c:errBars>
            <c:errBarType val="plus"/>
            <c:errValType val="cust"/>
            <c:noEndCap val="0"/>
            <c:plus>
              <c:numRef>
                <c:f>FAT!$C$16:$C$25</c:f>
                <c:numCache>
                  <c:formatCode>General</c:formatCode>
                  <c:ptCount val="10"/>
                  <c:pt idx="0">
                    <c:v>0.1576494</c:v>
                  </c:pt>
                  <c:pt idx="1">
                    <c:v>0.29466836000000002</c:v>
                  </c:pt>
                  <c:pt idx="2">
                    <c:v>0.39976381999999999</c:v>
                  </c:pt>
                  <c:pt idx="3">
                    <c:v>0.45012591000000002</c:v>
                  </c:pt>
                  <c:pt idx="4">
                    <c:v>0.1199838</c:v>
                  </c:pt>
                  <c:pt idx="5">
                    <c:v>0.14598326</c:v>
                  </c:pt>
                  <c:pt idx="6">
                    <c:v>0.11353903</c:v>
                  </c:pt>
                  <c:pt idx="7">
                    <c:v>0.27937629000000003</c:v>
                  </c:pt>
                  <c:pt idx="8">
                    <c:v>0.25520798</c:v>
                  </c:pt>
                  <c:pt idx="9">
                    <c:v>0.33562544999999999</c:v>
                  </c:pt>
                </c:numCache>
              </c:numRef>
            </c:plus>
            <c:spPr>
              <a:ln w="12727">
                <a:solidFill>
                  <a:srgbClr val="000000"/>
                </a:solidFill>
                <a:prstDash val="solid"/>
              </a:ln>
            </c:spPr>
          </c:errBars>
          <c:cat>
            <c:strRef>
              <c:f>FAT!$A$16:$A$25</c:f>
              <c:strCache>
                <c:ptCount val="10"/>
                <c:pt idx="0">
                  <c:v>D1_Fed</c:v>
                </c:pt>
                <c:pt idx="1">
                  <c:v>D2_Fed</c:v>
                </c:pt>
                <c:pt idx="2">
                  <c:v>D3_Fed</c:v>
                </c:pt>
                <c:pt idx="3">
                  <c:v>D4_Fed</c:v>
                </c:pt>
                <c:pt idx="4">
                  <c:v>D0_Fasted</c:v>
                </c:pt>
                <c:pt idx="5">
                  <c:v>D1_Fasted</c:v>
                </c:pt>
                <c:pt idx="6">
                  <c:v>D2_Fasted</c:v>
                </c:pt>
                <c:pt idx="7">
                  <c:v>D2_4hRefed</c:v>
                </c:pt>
                <c:pt idx="8">
                  <c:v>D3_24hRefed</c:v>
                </c:pt>
                <c:pt idx="9">
                  <c:v>D4_48hRefed</c:v>
                </c:pt>
              </c:strCache>
            </c:strRef>
          </c:cat>
          <c:val>
            <c:numRef>
              <c:f>FAT!$B$16:$B$25</c:f>
              <c:numCache>
                <c:formatCode>0.00</c:formatCode>
                <c:ptCount val="10"/>
                <c:pt idx="0">
                  <c:v>2.44</c:v>
                </c:pt>
                <c:pt idx="1">
                  <c:v>3.9483333300000001</c:v>
                </c:pt>
                <c:pt idx="2">
                  <c:v>4.1533333299999997</c:v>
                </c:pt>
                <c:pt idx="3">
                  <c:v>4.6900000000000004</c:v>
                </c:pt>
                <c:pt idx="4">
                  <c:v>1.7916666699999999</c:v>
                </c:pt>
                <c:pt idx="5">
                  <c:v>1.71333333</c:v>
                </c:pt>
                <c:pt idx="6">
                  <c:v>1.3333333300000001</c:v>
                </c:pt>
                <c:pt idx="7">
                  <c:v>2.71666667</c:v>
                </c:pt>
                <c:pt idx="8">
                  <c:v>3.4433333300000002</c:v>
                </c:pt>
                <c:pt idx="9">
                  <c:v>4.71666667000000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2642944"/>
        <c:axId val="222645248"/>
      </c:barChart>
      <c:catAx>
        <c:axId val="2226429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 sz="1200"/>
                  <a:t>Age_Treatment</a:t>
                </a:r>
              </a:p>
            </c:rich>
          </c:tx>
          <c:layout>
            <c:manualLayout>
              <c:xMode val="edge"/>
              <c:yMode val="edge"/>
              <c:x val="0.44776119402985076"/>
              <c:y val="0.90489913544668588"/>
            </c:manualLayout>
          </c:layout>
          <c:overlay val="0"/>
          <c:spPr>
            <a:noFill/>
            <a:ln w="25454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ln w="3182">
            <a:solidFill>
              <a:srgbClr val="000000"/>
            </a:solidFill>
            <a:prstDash val="solid"/>
          </a:ln>
        </c:spPr>
        <c:txPr>
          <a:bodyPr rot="-2700000" vert="horz"/>
          <a:lstStyle/>
          <a:p>
            <a:pPr>
              <a:defRPr sz="1052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222645248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22264524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 sz="1200" dirty="0" smtClean="0"/>
                  <a:t>Expression</a:t>
                </a:r>
                <a:endParaRPr lang="en-US" sz="1200" dirty="0"/>
              </a:p>
            </c:rich>
          </c:tx>
          <c:layout>
            <c:manualLayout>
              <c:xMode val="edge"/>
              <c:yMode val="edge"/>
              <c:x val="3.3078765757000972E-2"/>
              <c:y val="0.2625011944983312"/>
            </c:manualLayout>
          </c:layout>
          <c:overlay val="0"/>
          <c:spPr>
            <a:noFill/>
            <a:ln w="25454">
              <a:noFill/>
            </a:ln>
          </c:spPr>
        </c:title>
        <c:numFmt formatCode="0" sourceLinked="0"/>
        <c:majorTickMark val="out"/>
        <c:minorTickMark val="none"/>
        <c:tickLblPos val="nextTo"/>
        <c:spPr>
          <a:ln w="3182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1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222642944"/>
        <c:crosses val="autoZero"/>
        <c:crossBetween val="between"/>
        <c:majorUnit val="2"/>
      </c:valAx>
      <c:spPr>
        <a:noFill/>
        <a:ln w="25454"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02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1" i="1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 sz="1200"/>
              <a:t>GAPDH</a:t>
            </a:r>
          </a:p>
        </c:rich>
      </c:tx>
      <c:layout>
        <c:manualLayout>
          <c:xMode val="edge"/>
          <c:yMode val="edge"/>
          <c:x val="0.45224127636065337"/>
          <c:y val="2.3953632475403146E-2"/>
        </c:manualLayout>
      </c:layout>
      <c:overlay val="0"/>
      <c:spPr>
        <a:noFill/>
        <a:ln w="25399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316348195329087"/>
          <c:y val="0.10919540229885058"/>
          <c:w val="0.84501061571125269"/>
          <c:h val="0.5660919540229885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999FF"/>
            </a:solidFill>
            <a:ln w="25399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008000"/>
              </a:solidFill>
              <a:ln w="25399">
                <a:noFill/>
              </a:ln>
            </c:spPr>
          </c:dPt>
          <c:dPt>
            <c:idx val="1"/>
            <c:invertIfNegative val="0"/>
            <c:bubble3D val="0"/>
            <c:spPr>
              <a:solidFill>
                <a:srgbClr val="008000"/>
              </a:solidFill>
              <a:ln w="25399">
                <a:noFill/>
              </a:ln>
            </c:spPr>
          </c:dPt>
          <c:dPt>
            <c:idx val="2"/>
            <c:invertIfNegative val="0"/>
            <c:bubble3D val="0"/>
            <c:spPr>
              <a:solidFill>
                <a:srgbClr val="008000"/>
              </a:solidFill>
              <a:ln w="25399">
                <a:noFill/>
              </a:ln>
            </c:spPr>
          </c:dPt>
          <c:dPt>
            <c:idx val="3"/>
            <c:invertIfNegative val="0"/>
            <c:bubble3D val="0"/>
            <c:spPr>
              <a:solidFill>
                <a:srgbClr val="008000"/>
              </a:solidFill>
              <a:ln w="25399">
                <a:noFill/>
              </a:ln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  <a:ln w="25399">
                <a:noFill/>
              </a:ln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 w="25399">
                <a:noFill/>
              </a:ln>
            </c:spPr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 w="25399">
                <a:noFill/>
              </a:ln>
            </c:spPr>
          </c:dPt>
          <c:dPt>
            <c:idx val="7"/>
            <c:invertIfNegative val="0"/>
            <c:bubble3D val="0"/>
            <c:spPr>
              <a:solidFill>
                <a:srgbClr val="0000FF"/>
              </a:solidFill>
              <a:ln w="25399">
                <a:noFill/>
              </a:ln>
            </c:spPr>
          </c:dPt>
          <c:dPt>
            <c:idx val="8"/>
            <c:invertIfNegative val="0"/>
            <c:bubble3D val="0"/>
            <c:spPr>
              <a:solidFill>
                <a:srgbClr val="0000FF"/>
              </a:solidFill>
              <a:ln w="25399">
                <a:noFill/>
              </a:ln>
            </c:spPr>
          </c:dPt>
          <c:dPt>
            <c:idx val="9"/>
            <c:invertIfNegative val="0"/>
            <c:bubble3D val="0"/>
            <c:spPr>
              <a:solidFill>
                <a:srgbClr val="0000FF"/>
              </a:solidFill>
              <a:ln w="25399">
                <a:noFill/>
              </a:ln>
            </c:spPr>
          </c:dPt>
          <c:errBars>
            <c:errBarType val="plus"/>
            <c:errValType val="cust"/>
            <c:noEndCap val="0"/>
            <c:plus>
              <c:numRef>
                <c:f>GAPDH!$C$17:$C$26</c:f>
                <c:numCache>
                  <c:formatCode>General</c:formatCode>
                  <c:ptCount val="10"/>
                  <c:pt idx="0">
                    <c:v>8.0474290000000004E-2</c:v>
                  </c:pt>
                  <c:pt idx="1">
                    <c:v>0.14207196999999999</c:v>
                  </c:pt>
                  <c:pt idx="2">
                    <c:v>0.34346923000000001</c:v>
                  </c:pt>
                  <c:pt idx="3">
                    <c:v>0.14024780000000001</c:v>
                  </c:pt>
                  <c:pt idx="4">
                    <c:v>0.11503623</c:v>
                  </c:pt>
                  <c:pt idx="5">
                    <c:v>9.2508259999999995E-2</c:v>
                  </c:pt>
                  <c:pt idx="6">
                    <c:v>0.10935162</c:v>
                  </c:pt>
                  <c:pt idx="7">
                    <c:v>0.11944315</c:v>
                  </c:pt>
                  <c:pt idx="8">
                    <c:v>0.18427636</c:v>
                  </c:pt>
                  <c:pt idx="9">
                    <c:v>0.17225304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GAPDH!$A$17:$A$26</c:f>
              <c:strCache>
                <c:ptCount val="10"/>
                <c:pt idx="0">
                  <c:v>D1_Fed</c:v>
                </c:pt>
                <c:pt idx="1">
                  <c:v>D2_Fed</c:v>
                </c:pt>
                <c:pt idx="2">
                  <c:v>D3_Fed</c:v>
                </c:pt>
                <c:pt idx="3">
                  <c:v>D4_Fed</c:v>
                </c:pt>
                <c:pt idx="4">
                  <c:v>D0_Fasted</c:v>
                </c:pt>
                <c:pt idx="5">
                  <c:v>D1_Fasted</c:v>
                </c:pt>
                <c:pt idx="6">
                  <c:v>D2_Fasted</c:v>
                </c:pt>
                <c:pt idx="7">
                  <c:v>D2_4hRefed</c:v>
                </c:pt>
                <c:pt idx="8">
                  <c:v>D3_24hRefed</c:v>
                </c:pt>
                <c:pt idx="9">
                  <c:v>D4_48hRefed</c:v>
                </c:pt>
              </c:strCache>
            </c:strRef>
          </c:cat>
          <c:val>
            <c:numRef>
              <c:f>GAPDH!$B$17:$B$26</c:f>
              <c:numCache>
                <c:formatCode>0.000</c:formatCode>
                <c:ptCount val="10"/>
                <c:pt idx="0">
                  <c:v>1.61166667</c:v>
                </c:pt>
                <c:pt idx="1">
                  <c:v>2.1933333300000002</c:v>
                </c:pt>
                <c:pt idx="2">
                  <c:v>2.8633333300000001</c:v>
                </c:pt>
                <c:pt idx="3">
                  <c:v>3.1416666700000002</c:v>
                </c:pt>
                <c:pt idx="4">
                  <c:v>1.42</c:v>
                </c:pt>
                <c:pt idx="5">
                  <c:v>1.79666667</c:v>
                </c:pt>
                <c:pt idx="6">
                  <c:v>1.69333333</c:v>
                </c:pt>
                <c:pt idx="7">
                  <c:v>1.77</c:v>
                </c:pt>
                <c:pt idx="8">
                  <c:v>2.0933333300000001</c:v>
                </c:pt>
                <c:pt idx="9">
                  <c:v>2.95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38838912"/>
        <c:axId val="238841216"/>
      </c:barChart>
      <c:catAx>
        <c:axId val="2388389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 sz="1200"/>
                  <a:t>Age_Treatment</a:t>
                </a:r>
              </a:p>
            </c:rich>
          </c:tx>
          <c:layout>
            <c:manualLayout>
              <c:xMode val="edge"/>
              <c:yMode val="edge"/>
              <c:x val="0.44585987261146498"/>
              <c:y val="0.91091954022988508"/>
            </c:manualLayout>
          </c:layout>
          <c:overlay val="0"/>
          <c:spPr>
            <a:noFill/>
            <a:ln w="25399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270000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23884121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23884121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 sz="1200" dirty="0" smtClean="0"/>
                  <a:t>Expression</a:t>
                </a:r>
                <a:endParaRPr lang="en-US" sz="1200" dirty="0"/>
              </a:p>
            </c:rich>
          </c:tx>
          <c:layout>
            <c:manualLayout>
              <c:xMode val="edge"/>
              <c:yMode val="edge"/>
              <c:x val="1.698510577744047E-2"/>
              <c:y val="0.23672978977435882"/>
            </c:manualLayout>
          </c:layout>
          <c:overlay val="0"/>
          <c:spPr>
            <a:noFill/>
            <a:ln w="25399">
              <a:noFill/>
            </a:ln>
          </c:spPr>
        </c:title>
        <c:numFmt formatCode="0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1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238838912"/>
        <c:crosses val="autoZero"/>
        <c:crossBetween val="between"/>
        <c:majorUnit val="1"/>
      </c:valAx>
      <c:spPr>
        <a:noFill/>
        <a:ln w="25399"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1" i="1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 sz="1200"/>
              <a:t>COX7A2L</a:t>
            </a:r>
          </a:p>
        </c:rich>
      </c:tx>
      <c:layout>
        <c:manualLayout>
          <c:xMode val="edge"/>
          <c:yMode val="edge"/>
          <c:x val="0.4288747346072187"/>
          <c:y val="2.0057306590257881E-2"/>
        </c:manualLayout>
      </c:layout>
      <c:overlay val="0"/>
      <c:spPr>
        <a:noFill/>
        <a:ln w="25399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3800424628450106"/>
          <c:y val="0.10398282032927703"/>
          <c:w val="0.8428874734607219"/>
          <c:h val="0.5636390762159514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999FF"/>
            </a:solidFill>
            <a:ln w="25399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008000"/>
              </a:solidFill>
              <a:ln w="25399">
                <a:noFill/>
              </a:ln>
            </c:spPr>
          </c:dPt>
          <c:dPt>
            <c:idx val="1"/>
            <c:invertIfNegative val="0"/>
            <c:bubble3D val="0"/>
            <c:spPr>
              <a:solidFill>
                <a:srgbClr val="008000"/>
              </a:solidFill>
              <a:ln w="25399">
                <a:noFill/>
              </a:ln>
            </c:spPr>
          </c:dPt>
          <c:dPt>
            <c:idx val="2"/>
            <c:invertIfNegative val="0"/>
            <c:bubble3D val="0"/>
            <c:spPr>
              <a:solidFill>
                <a:srgbClr val="008000"/>
              </a:solidFill>
              <a:ln w="25399">
                <a:noFill/>
              </a:ln>
            </c:spPr>
          </c:dPt>
          <c:dPt>
            <c:idx val="3"/>
            <c:invertIfNegative val="0"/>
            <c:bubble3D val="0"/>
            <c:spPr>
              <a:solidFill>
                <a:srgbClr val="008000"/>
              </a:solidFill>
              <a:ln w="25399">
                <a:noFill/>
              </a:ln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  <a:ln w="25399">
                <a:noFill/>
              </a:ln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 w="25399">
                <a:noFill/>
              </a:ln>
            </c:spPr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 w="25399">
                <a:noFill/>
              </a:ln>
            </c:spPr>
          </c:dPt>
          <c:dPt>
            <c:idx val="7"/>
            <c:invertIfNegative val="0"/>
            <c:bubble3D val="0"/>
            <c:spPr>
              <a:solidFill>
                <a:srgbClr val="0000FF"/>
              </a:solidFill>
              <a:ln w="25399">
                <a:noFill/>
              </a:ln>
            </c:spPr>
          </c:dPt>
          <c:dPt>
            <c:idx val="8"/>
            <c:invertIfNegative val="0"/>
            <c:bubble3D val="0"/>
            <c:spPr>
              <a:solidFill>
                <a:srgbClr val="0000FF"/>
              </a:solidFill>
              <a:ln w="25399">
                <a:noFill/>
              </a:ln>
            </c:spPr>
          </c:dPt>
          <c:dPt>
            <c:idx val="9"/>
            <c:invertIfNegative val="0"/>
            <c:bubble3D val="0"/>
            <c:spPr>
              <a:solidFill>
                <a:srgbClr val="0000FF"/>
              </a:solidFill>
              <a:ln w="25399">
                <a:noFill/>
              </a:ln>
            </c:spPr>
          </c:dPt>
          <c:errBars>
            <c:errBarType val="plus"/>
            <c:errValType val="cust"/>
            <c:noEndCap val="0"/>
            <c:plus>
              <c:numRef>
                <c:f>COX7A2L!$C$17:$C$26</c:f>
                <c:numCache>
                  <c:formatCode>General</c:formatCode>
                  <c:ptCount val="10"/>
                  <c:pt idx="0">
                    <c:v>4.3563490000000003E-2</c:v>
                  </c:pt>
                  <c:pt idx="1">
                    <c:v>5.3913509999999998E-2</c:v>
                  </c:pt>
                  <c:pt idx="2">
                    <c:v>2.4312779999999999E-2</c:v>
                  </c:pt>
                  <c:pt idx="3">
                    <c:v>2.231093E-2</c:v>
                  </c:pt>
                  <c:pt idx="4">
                    <c:v>4.7375569999999999E-2</c:v>
                  </c:pt>
                  <c:pt idx="5">
                    <c:v>2.4415389999999999E-2</c:v>
                  </c:pt>
                  <c:pt idx="6">
                    <c:v>5.8161650000000002E-2</c:v>
                  </c:pt>
                  <c:pt idx="7">
                    <c:v>5.1316010000000002E-2</c:v>
                  </c:pt>
                  <c:pt idx="8">
                    <c:v>6.680403E-2</c:v>
                  </c:pt>
                  <c:pt idx="9">
                    <c:v>3.8333329999999999E-2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COX7A2L!$A$17:$A$26</c:f>
              <c:strCache>
                <c:ptCount val="10"/>
                <c:pt idx="0">
                  <c:v>D1_Fed</c:v>
                </c:pt>
                <c:pt idx="1">
                  <c:v>D2_Fed</c:v>
                </c:pt>
                <c:pt idx="2">
                  <c:v>D3_Fed</c:v>
                </c:pt>
                <c:pt idx="3">
                  <c:v>D4_Fed</c:v>
                </c:pt>
                <c:pt idx="4">
                  <c:v>D0_Fasted</c:v>
                </c:pt>
                <c:pt idx="5">
                  <c:v>D1_Fasted</c:v>
                </c:pt>
                <c:pt idx="6">
                  <c:v>D2_Fasted</c:v>
                </c:pt>
                <c:pt idx="7">
                  <c:v>D2_4hRefed</c:v>
                </c:pt>
                <c:pt idx="8">
                  <c:v>D3_24hRefed</c:v>
                </c:pt>
                <c:pt idx="9">
                  <c:v>D4_48hRefed</c:v>
                </c:pt>
              </c:strCache>
            </c:strRef>
          </c:cat>
          <c:val>
            <c:numRef>
              <c:f>COX7A2L!$B$17:$B$26</c:f>
              <c:numCache>
                <c:formatCode>0.0000</c:formatCode>
                <c:ptCount val="10"/>
                <c:pt idx="0">
                  <c:v>1.1966666699999999</c:v>
                </c:pt>
                <c:pt idx="1">
                  <c:v>1.26</c:v>
                </c:pt>
                <c:pt idx="2">
                  <c:v>1.25333333</c:v>
                </c:pt>
                <c:pt idx="3">
                  <c:v>1.3033333300000001</c:v>
                </c:pt>
                <c:pt idx="4">
                  <c:v>1.1966666699999999</c:v>
                </c:pt>
                <c:pt idx="5">
                  <c:v>1.11166667</c:v>
                </c:pt>
                <c:pt idx="6">
                  <c:v>1.15166667</c:v>
                </c:pt>
                <c:pt idx="7">
                  <c:v>1.24</c:v>
                </c:pt>
                <c:pt idx="8">
                  <c:v>1.1683333300000001</c:v>
                </c:pt>
                <c:pt idx="9">
                  <c:v>1.27833332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9660672"/>
        <c:axId val="49662592"/>
      </c:barChart>
      <c:catAx>
        <c:axId val="496606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 sz="1200"/>
                  <a:t>Age_Treatment</a:t>
                </a:r>
              </a:p>
            </c:rich>
          </c:tx>
          <c:layout>
            <c:manualLayout>
              <c:xMode val="edge"/>
              <c:yMode val="edge"/>
              <c:x val="0.45010615711252655"/>
              <c:y val="0.90257879656160456"/>
            </c:manualLayout>
          </c:layout>
          <c:overlay val="0"/>
          <c:spPr>
            <a:noFill/>
            <a:ln w="25399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270000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9662592"/>
        <c:crossesAt val="0"/>
        <c:auto val="1"/>
        <c:lblAlgn val="ctr"/>
        <c:lblOffset val="100"/>
        <c:tickLblSkip val="1"/>
        <c:tickMarkSkip val="1"/>
        <c:noMultiLvlLbl val="0"/>
      </c:catAx>
      <c:valAx>
        <c:axId val="49662592"/>
        <c:scaling>
          <c:orientation val="minMax"/>
          <c:max val="1.5"/>
        </c:scaling>
        <c:delete val="0"/>
        <c:axPos val="l"/>
        <c:title>
          <c:tx>
            <c:rich>
              <a:bodyPr/>
              <a:lstStyle/>
              <a:p>
                <a:pPr>
                  <a:defRPr sz="12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 sz="1200" dirty="0" smtClean="0"/>
                  <a:t> Expression</a:t>
                </a:r>
                <a:endParaRPr lang="en-US" sz="1200" dirty="0"/>
              </a:p>
            </c:rich>
          </c:tx>
          <c:layout>
            <c:manualLayout>
              <c:xMode val="edge"/>
              <c:yMode val="edge"/>
              <c:x val="8.4925690021231421E-3"/>
              <c:y val="0.19197707736389685"/>
            </c:manualLayout>
          </c:layout>
          <c:overlay val="0"/>
          <c:spPr>
            <a:noFill/>
            <a:ln w="25399">
              <a:noFill/>
            </a:ln>
          </c:spPr>
        </c:title>
        <c:numFmt formatCode="0.0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1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9660672"/>
        <c:crosses val="autoZero"/>
        <c:crossBetween val="between"/>
        <c:majorUnit val="0.5"/>
      </c:valAx>
      <c:spPr>
        <a:noFill/>
        <a:ln w="25399"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1" i="1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 sz="1200"/>
              <a:t>RPL14</a:t>
            </a:r>
          </a:p>
        </c:rich>
      </c:tx>
      <c:layout>
        <c:manualLayout>
          <c:xMode val="edge"/>
          <c:yMode val="edge"/>
          <c:x val="0.45202558635394458"/>
          <c:y val="0.02"/>
        </c:manualLayout>
      </c:layout>
      <c:overlay val="0"/>
      <c:spPr>
        <a:noFill/>
        <a:ln w="25401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4285714285714285"/>
          <c:y val="0.1075900102181884"/>
          <c:w val="0.83368869936034118"/>
          <c:h val="0.560065516619582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999FF"/>
            </a:solidFill>
            <a:ln w="25401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008000"/>
              </a:solidFill>
              <a:ln w="25401">
                <a:noFill/>
              </a:ln>
            </c:spPr>
          </c:dPt>
          <c:dPt>
            <c:idx val="1"/>
            <c:invertIfNegative val="0"/>
            <c:bubble3D val="0"/>
            <c:spPr>
              <a:solidFill>
                <a:srgbClr val="008000"/>
              </a:solidFill>
              <a:ln w="25401">
                <a:noFill/>
              </a:ln>
            </c:spPr>
          </c:dPt>
          <c:dPt>
            <c:idx val="2"/>
            <c:invertIfNegative val="0"/>
            <c:bubble3D val="0"/>
            <c:spPr>
              <a:solidFill>
                <a:srgbClr val="008000"/>
              </a:solidFill>
              <a:ln w="25401">
                <a:noFill/>
              </a:ln>
            </c:spPr>
          </c:dPt>
          <c:dPt>
            <c:idx val="3"/>
            <c:invertIfNegative val="0"/>
            <c:bubble3D val="0"/>
            <c:spPr>
              <a:solidFill>
                <a:srgbClr val="008000"/>
              </a:solidFill>
              <a:ln w="25401">
                <a:noFill/>
              </a:ln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  <a:ln w="25401">
                <a:noFill/>
              </a:ln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 w="25401">
                <a:noFill/>
              </a:ln>
            </c:spPr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 w="25401">
                <a:noFill/>
              </a:ln>
            </c:spPr>
          </c:dPt>
          <c:dPt>
            <c:idx val="7"/>
            <c:invertIfNegative val="0"/>
            <c:bubble3D val="0"/>
            <c:spPr>
              <a:solidFill>
                <a:srgbClr val="0000FF"/>
              </a:solidFill>
              <a:ln w="25401">
                <a:noFill/>
              </a:ln>
            </c:spPr>
          </c:dPt>
          <c:dPt>
            <c:idx val="8"/>
            <c:invertIfNegative val="0"/>
            <c:bubble3D val="0"/>
            <c:spPr>
              <a:solidFill>
                <a:srgbClr val="0000FF"/>
              </a:solidFill>
              <a:ln w="25401">
                <a:noFill/>
              </a:ln>
            </c:spPr>
          </c:dPt>
          <c:dPt>
            <c:idx val="9"/>
            <c:invertIfNegative val="0"/>
            <c:bubble3D val="0"/>
            <c:spPr>
              <a:solidFill>
                <a:srgbClr val="0000FF"/>
              </a:solidFill>
              <a:ln w="25401">
                <a:noFill/>
              </a:ln>
            </c:spPr>
          </c:dPt>
          <c:errBars>
            <c:errBarType val="plus"/>
            <c:errValType val="cust"/>
            <c:noEndCap val="0"/>
            <c:plus>
              <c:numRef>
                <c:f>'RPL14'!$C$15:$C$24</c:f>
                <c:numCache>
                  <c:formatCode>General</c:formatCode>
                  <c:ptCount val="10"/>
                  <c:pt idx="0">
                    <c:v>4.3792440000000002E-2</c:v>
                  </c:pt>
                  <c:pt idx="1">
                    <c:v>5.016085E-2</c:v>
                  </c:pt>
                  <c:pt idx="2">
                    <c:v>2.3475759999999998E-2</c:v>
                  </c:pt>
                  <c:pt idx="3">
                    <c:v>1.6616590000000001E-2</c:v>
                  </c:pt>
                  <c:pt idx="4">
                    <c:v>4.4478459999999997E-2</c:v>
                  </c:pt>
                  <c:pt idx="5">
                    <c:v>2.6257269999999999E-2</c:v>
                  </c:pt>
                  <c:pt idx="6">
                    <c:v>5.8977399999999999E-2</c:v>
                  </c:pt>
                  <c:pt idx="7">
                    <c:v>5.4569020000000003E-2</c:v>
                  </c:pt>
                  <c:pt idx="8">
                    <c:v>6.6770750000000004E-2</c:v>
                  </c:pt>
                  <c:pt idx="9">
                    <c:v>3.4713109999999998E-2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RPL14'!$A$15:$A$24</c:f>
              <c:strCache>
                <c:ptCount val="10"/>
                <c:pt idx="0">
                  <c:v>D1_Fed</c:v>
                </c:pt>
                <c:pt idx="1">
                  <c:v>D2_Fed</c:v>
                </c:pt>
                <c:pt idx="2">
                  <c:v>D3_Fed</c:v>
                </c:pt>
                <c:pt idx="3">
                  <c:v>D4_Fed</c:v>
                </c:pt>
                <c:pt idx="4">
                  <c:v>D0_Fasted</c:v>
                </c:pt>
                <c:pt idx="5">
                  <c:v>D1_Fasted</c:v>
                </c:pt>
                <c:pt idx="6">
                  <c:v>D2_Fasted</c:v>
                </c:pt>
                <c:pt idx="7">
                  <c:v>D2_4hRefed</c:v>
                </c:pt>
                <c:pt idx="8">
                  <c:v>D3_24hRefed</c:v>
                </c:pt>
                <c:pt idx="9">
                  <c:v>D4_48hRefed</c:v>
                </c:pt>
              </c:strCache>
            </c:strRef>
          </c:cat>
          <c:val>
            <c:numRef>
              <c:f>'RPL14'!$B$15:$B$24</c:f>
              <c:numCache>
                <c:formatCode>0.00</c:formatCode>
                <c:ptCount val="10"/>
                <c:pt idx="0">
                  <c:v>1.20333333</c:v>
                </c:pt>
                <c:pt idx="1">
                  <c:v>1.14833333</c:v>
                </c:pt>
                <c:pt idx="2">
                  <c:v>1.1433333299999999</c:v>
                </c:pt>
                <c:pt idx="3">
                  <c:v>1.09833333</c:v>
                </c:pt>
                <c:pt idx="4">
                  <c:v>1.2050000000000001</c:v>
                </c:pt>
                <c:pt idx="5">
                  <c:v>1.2916666699999999</c:v>
                </c:pt>
                <c:pt idx="6">
                  <c:v>1.2549999999999999</c:v>
                </c:pt>
                <c:pt idx="7">
                  <c:v>1.1666666699999999</c:v>
                </c:pt>
                <c:pt idx="8">
                  <c:v>1.2450000000000001</c:v>
                </c:pt>
                <c:pt idx="9">
                  <c:v>1.1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9765376"/>
        <c:axId val="49767552"/>
      </c:barChart>
      <c:catAx>
        <c:axId val="497653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 sz="1200"/>
                  <a:t>Age_Treatment</a:t>
                </a:r>
              </a:p>
            </c:rich>
          </c:tx>
          <c:layout>
            <c:manualLayout>
              <c:xMode val="edge"/>
              <c:yMode val="edge"/>
              <c:x val="0.43923240938166314"/>
              <c:y val="0.90857142857142859"/>
            </c:manualLayout>
          </c:layout>
          <c:overlay val="0"/>
          <c:spPr>
            <a:noFill/>
            <a:ln w="25401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2700000" vert="horz"/>
          <a:lstStyle/>
          <a:p>
            <a:pPr>
              <a:defRPr sz="105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9767552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49767552"/>
        <c:scaling>
          <c:orientation val="minMax"/>
          <c:max val="1.5"/>
        </c:scaling>
        <c:delete val="0"/>
        <c:axPos val="l"/>
        <c:title>
          <c:tx>
            <c:rich>
              <a:bodyPr/>
              <a:lstStyle/>
              <a:p>
                <a:pPr>
                  <a:defRPr sz="12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 sz="1200" dirty="0" smtClean="0"/>
                  <a:t>Expression</a:t>
                </a:r>
                <a:endParaRPr lang="en-US" sz="1200" dirty="0"/>
              </a:p>
            </c:rich>
          </c:tx>
          <c:layout>
            <c:manualLayout>
              <c:xMode val="edge"/>
              <c:yMode val="edge"/>
              <c:x val="2.8227645921484008E-3"/>
              <c:y val="0.17341317545230511"/>
            </c:manualLayout>
          </c:layout>
          <c:overlay val="0"/>
          <c:spPr>
            <a:noFill/>
            <a:ln w="25401">
              <a:noFill/>
            </a:ln>
          </c:spPr>
        </c:title>
        <c:numFmt formatCode="0.0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1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9765376"/>
        <c:crosses val="autoZero"/>
        <c:crossBetween val="between"/>
        <c:majorUnit val="0.5"/>
      </c:valAx>
      <c:spPr>
        <a:noFill/>
        <a:ln w="25401"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5F7C2-ABF4-4C60-818B-64B903963634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F793-FDA3-4026-81CF-D6D8EC82C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4729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5F7C2-ABF4-4C60-818B-64B903963634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F793-FDA3-4026-81CF-D6D8EC82C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635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5F7C2-ABF4-4C60-818B-64B903963634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F793-FDA3-4026-81CF-D6D8EC82C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3066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5F7C2-ABF4-4C60-818B-64B903963634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F793-FDA3-4026-81CF-D6D8EC82C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41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5F7C2-ABF4-4C60-818B-64B903963634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F793-FDA3-4026-81CF-D6D8EC82C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574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5F7C2-ABF4-4C60-818B-64B903963634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F793-FDA3-4026-81CF-D6D8EC82C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1283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5F7C2-ABF4-4C60-818B-64B903963634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F793-FDA3-4026-81CF-D6D8EC82C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695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5F7C2-ABF4-4C60-818B-64B903963634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F793-FDA3-4026-81CF-D6D8EC82C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032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5F7C2-ABF4-4C60-818B-64B903963634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F793-FDA3-4026-81CF-D6D8EC82C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70279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5F7C2-ABF4-4C60-818B-64B903963634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F793-FDA3-4026-81CF-D6D8EC82C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5850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5F7C2-ABF4-4C60-818B-64B903963634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F793-FDA3-4026-81CF-D6D8EC82C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0866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15F7C2-ABF4-4C60-818B-64B903963634}" type="datetimeFigureOut">
              <a:rPr lang="en-US" smtClean="0"/>
              <a:t>12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67F793-FDA3-4026-81CF-D6D8EC82C7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9512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-50713" y="-21815"/>
            <a:ext cx="9178291" cy="6819490"/>
            <a:chOff x="-50713" y="-21815"/>
            <a:chExt cx="9178291" cy="6819490"/>
          </a:xfrm>
        </p:grpSpPr>
        <p:grpSp>
          <p:nvGrpSpPr>
            <p:cNvPr id="3" name="Group 2"/>
            <p:cNvGrpSpPr/>
            <p:nvPr/>
          </p:nvGrpSpPr>
          <p:grpSpPr>
            <a:xfrm>
              <a:off x="-50713" y="32"/>
              <a:ext cx="4571936" cy="3411474"/>
              <a:chOff x="4572032" y="3425857"/>
              <a:chExt cx="4571936" cy="3411474"/>
            </a:xfrm>
          </p:grpSpPr>
          <p:graphicFrame>
            <p:nvGraphicFramePr>
              <p:cNvPr id="21" name="Object 4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708304872"/>
                  </p:ext>
                </p:extLst>
              </p:nvPr>
            </p:nvGraphicFramePr>
            <p:xfrm>
              <a:off x="4572032" y="3425857"/>
              <a:ext cx="4571936" cy="341147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22" name="Text Box 59"/>
              <p:cNvSpPr txBox="1">
                <a:spLocks noChangeArrowheads="1"/>
              </p:cNvSpPr>
              <p:nvPr/>
            </p:nvSpPr>
            <p:spPr bwMode="auto">
              <a:xfrm>
                <a:off x="5270500" y="4553773"/>
                <a:ext cx="361950" cy="2746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 dirty="0"/>
                  <a:t>de</a:t>
                </a:r>
              </a:p>
            </p:txBody>
          </p:sp>
          <p:sp>
            <p:nvSpPr>
              <p:cNvPr id="23" name="Text Box 60"/>
              <p:cNvSpPr txBox="1">
                <a:spLocks noChangeArrowheads="1"/>
              </p:cNvSpPr>
              <p:nvPr/>
            </p:nvSpPr>
            <p:spPr bwMode="auto">
              <a:xfrm>
                <a:off x="5646738" y="4072158"/>
                <a:ext cx="361950" cy="2746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 dirty="0"/>
                  <a:t>ab</a:t>
                </a:r>
              </a:p>
            </p:txBody>
          </p:sp>
          <p:sp>
            <p:nvSpPr>
              <p:cNvPr id="24" name="Text Box 61"/>
              <p:cNvSpPr txBox="1">
                <a:spLocks noChangeArrowheads="1"/>
              </p:cNvSpPr>
              <p:nvPr/>
            </p:nvSpPr>
            <p:spPr bwMode="auto">
              <a:xfrm>
                <a:off x="6036660" y="3963223"/>
                <a:ext cx="361950" cy="2746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 dirty="0"/>
                  <a:t>ab</a:t>
                </a:r>
              </a:p>
            </p:txBody>
          </p:sp>
          <p:sp>
            <p:nvSpPr>
              <p:cNvPr id="25" name="Text Box 62"/>
              <p:cNvSpPr txBox="1">
                <a:spLocks noChangeArrowheads="1"/>
              </p:cNvSpPr>
              <p:nvPr/>
            </p:nvSpPr>
            <p:spPr bwMode="auto">
              <a:xfrm>
                <a:off x="6455158" y="3797138"/>
                <a:ext cx="268287" cy="2746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/>
                  <a:t>a</a:t>
                </a:r>
              </a:p>
            </p:txBody>
          </p:sp>
          <p:sp>
            <p:nvSpPr>
              <p:cNvPr id="26" name="Text Box 63"/>
              <p:cNvSpPr txBox="1">
                <a:spLocks noChangeArrowheads="1"/>
              </p:cNvSpPr>
              <p:nvPr/>
            </p:nvSpPr>
            <p:spPr bwMode="auto">
              <a:xfrm>
                <a:off x="6821870" y="4745860"/>
                <a:ext cx="319088" cy="2746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 dirty="0" err="1"/>
                  <a:t>fe</a:t>
                </a:r>
                <a:endParaRPr lang="en-US" altLang="en-US" sz="1200" b="1" dirty="0"/>
              </a:p>
            </p:txBody>
          </p:sp>
          <p:sp>
            <p:nvSpPr>
              <p:cNvPr id="27" name="Text Box 64"/>
              <p:cNvSpPr txBox="1">
                <a:spLocks noChangeArrowheads="1"/>
              </p:cNvSpPr>
              <p:nvPr/>
            </p:nvSpPr>
            <p:spPr bwMode="auto">
              <a:xfrm>
                <a:off x="7207030" y="4741700"/>
                <a:ext cx="319088" cy="2746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 dirty="0" err="1"/>
                  <a:t>fe</a:t>
                </a:r>
                <a:endParaRPr lang="en-US" altLang="en-US" sz="1200" b="1" dirty="0"/>
              </a:p>
            </p:txBody>
          </p:sp>
          <p:sp>
            <p:nvSpPr>
              <p:cNvPr id="28" name="Text Box 65"/>
              <p:cNvSpPr txBox="1">
                <a:spLocks noChangeArrowheads="1"/>
              </p:cNvSpPr>
              <p:nvPr/>
            </p:nvSpPr>
            <p:spPr bwMode="auto">
              <a:xfrm>
                <a:off x="7616605" y="4899245"/>
                <a:ext cx="234950" cy="2746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/>
                  <a:t>f</a:t>
                </a:r>
              </a:p>
            </p:txBody>
          </p:sp>
          <p:sp>
            <p:nvSpPr>
              <p:cNvPr id="29" name="Text Box 66"/>
              <p:cNvSpPr txBox="1">
                <a:spLocks noChangeArrowheads="1"/>
              </p:cNvSpPr>
              <p:nvPr/>
            </p:nvSpPr>
            <p:spPr bwMode="auto">
              <a:xfrm>
                <a:off x="7934708" y="4434108"/>
                <a:ext cx="361950" cy="2746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 dirty="0"/>
                  <a:t>dc</a:t>
                </a:r>
              </a:p>
            </p:txBody>
          </p:sp>
          <p:sp>
            <p:nvSpPr>
              <p:cNvPr id="30" name="Text Box 67"/>
              <p:cNvSpPr txBox="1">
                <a:spLocks noChangeArrowheads="1"/>
              </p:cNvSpPr>
              <p:nvPr/>
            </p:nvSpPr>
            <p:spPr bwMode="auto">
              <a:xfrm>
                <a:off x="8324630" y="4246783"/>
                <a:ext cx="361950" cy="2746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 dirty="0" err="1"/>
                  <a:t>bc</a:t>
                </a:r>
                <a:endParaRPr lang="en-US" altLang="en-US" sz="1200" b="1" dirty="0"/>
              </a:p>
            </p:txBody>
          </p:sp>
          <p:sp>
            <p:nvSpPr>
              <p:cNvPr id="31" name="Text Box 68"/>
              <p:cNvSpPr txBox="1">
                <a:spLocks noChangeArrowheads="1"/>
              </p:cNvSpPr>
              <p:nvPr/>
            </p:nvSpPr>
            <p:spPr bwMode="auto">
              <a:xfrm>
                <a:off x="8769895" y="3813615"/>
                <a:ext cx="268288" cy="2746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 dirty="0"/>
                  <a:t>a</a:t>
                </a:r>
              </a:p>
            </p:txBody>
          </p:sp>
        </p:grpSp>
        <p:sp>
          <p:nvSpPr>
            <p:cNvPr id="4" name="Text Box 65"/>
            <p:cNvSpPr txBox="1">
              <a:spLocks noChangeArrowheads="1"/>
            </p:cNvSpPr>
            <p:nvPr/>
          </p:nvSpPr>
          <p:spPr bwMode="auto">
            <a:xfrm>
              <a:off x="2993860" y="1494440"/>
              <a:ext cx="18473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endParaRPr lang="en-US" altLang="en-US" sz="1200" b="1" dirty="0"/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4647653" y="-12588"/>
              <a:ext cx="4479925" cy="3308350"/>
              <a:chOff x="4647653" y="-12588"/>
              <a:chExt cx="4479925" cy="3308350"/>
            </a:xfrm>
          </p:grpSpPr>
          <p:graphicFrame>
            <p:nvGraphicFramePr>
              <p:cNvPr id="10" name="Object 2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626212968"/>
                  </p:ext>
                </p:extLst>
              </p:nvPr>
            </p:nvGraphicFramePr>
            <p:xfrm>
              <a:off x="4647653" y="-12588"/>
              <a:ext cx="4479925" cy="33083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1" name="Text Box 27"/>
              <p:cNvSpPr txBox="1">
                <a:spLocks noChangeArrowheads="1"/>
              </p:cNvSpPr>
              <p:nvPr/>
            </p:nvSpPr>
            <p:spPr bwMode="auto">
              <a:xfrm>
                <a:off x="5281066" y="1181212"/>
                <a:ext cx="277812" cy="2746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/>
                  <a:t>d</a:t>
                </a:r>
              </a:p>
            </p:txBody>
          </p:sp>
          <p:sp>
            <p:nvSpPr>
              <p:cNvPr id="12" name="Text Box 28"/>
              <p:cNvSpPr txBox="1">
                <a:spLocks noChangeArrowheads="1"/>
              </p:cNvSpPr>
              <p:nvPr/>
            </p:nvSpPr>
            <p:spPr bwMode="auto">
              <a:xfrm>
                <a:off x="5674766" y="874825"/>
                <a:ext cx="277812" cy="2746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/>
                  <a:t>b</a:t>
                </a:r>
              </a:p>
            </p:txBody>
          </p:sp>
          <p:sp>
            <p:nvSpPr>
              <p:cNvPr id="13" name="Text Box 29"/>
              <p:cNvSpPr txBox="1">
                <a:spLocks noChangeArrowheads="1"/>
              </p:cNvSpPr>
              <p:nvPr/>
            </p:nvSpPr>
            <p:spPr bwMode="auto">
              <a:xfrm>
                <a:off x="6049416" y="474775"/>
                <a:ext cx="268287" cy="2746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/>
                  <a:t>a</a:t>
                </a:r>
              </a:p>
            </p:txBody>
          </p:sp>
          <p:sp>
            <p:nvSpPr>
              <p:cNvPr id="14" name="Text Box 30"/>
              <p:cNvSpPr txBox="1">
                <a:spLocks noChangeArrowheads="1"/>
              </p:cNvSpPr>
              <p:nvPr/>
            </p:nvSpPr>
            <p:spPr bwMode="auto">
              <a:xfrm>
                <a:off x="6411366" y="439850"/>
                <a:ext cx="268287" cy="2746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/>
                  <a:t>a</a:t>
                </a:r>
              </a:p>
            </p:txBody>
          </p:sp>
          <p:sp>
            <p:nvSpPr>
              <p:cNvPr id="15" name="Text Box 31"/>
              <p:cNvSpPr txBox="1">
                <a:spLocks noChangeArrowheads="1"/>
              </p:cNvSpPr>
              <p:nvPr/>
            </p:nvSpPr>
            <p:spPr bwMode="auto">
              <a:xfrm>
                <a:off x="6778078" y="1254237"/>
                <a:ext cx="277813" cy="2746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/>
                  <a:t>d</a:t>
                </a:r>
              </a:p>
            </p:txBody>
          </p:sp>
          <p:sp>
            <p:nvSpPr>
              <p:cNvPr id="16" name="Text Box 32"/>
              <p:cNvSpPr txBox="1">
                <a:spLocks noChangeArrowheads="1"/>
              </p:cNvSpPr>
              <p:nvPr/>
            </p:nvSpPr>
            <p:spPr bwMode="auto">
              <a:xfrm>
                <a:off x="7092403" y="1089137"/>
                <a:ext cx="455613" cy="2746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/>
                  <a:t>bcd</a:t>
                </a:r>
              </a:p>
            </p:txBody>
          </p:sp>
          <p:sp>
            <p:nvSpPr>
              <p:cNvPr id="17" name="Text Box 33"/>
              <p:cNvSpPr txBox="1">
                <a:spLocks noChangeArrowheads="1"/>
              </p:cNvSpPr>
              <p:nvPr/>
            </p:nvSpPr>
            <p:spPr bwMode="auto">
              <a:xfrm>
                <a:off x="7511503" y="1138350"/>
                <a:ext cx="361950" cy="2746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/>
                  <a:t>cd</a:t>
                </a:r>
              </a:p>
            </p:txBody>
          </p:sp>
          <p:sp>
            <p:nvSpPr>
              <p:cNvPr id="18" name="Text Box 34"/>
              <p:cNvSpPr txBox="1">
                <a:spLocks noChangeArrowheads="1"/>
              </p:cNvSpPr>
              <p:nvPr/>
            </p:nvSpPr>
            <p:spPr bwMode="auto">
              <a:xfrm>
                <a:off x="7819478" y="1089137"/>
                <a:ext cx="455613" cy="2746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/>
                  <a:t>bcd</a:t>
                </a:r>
              </a:p>
            </p:txBody>
          </p:sp>
          <p:sp>
            <p:nvSpPr>
              <p:cNvPr id="19" name="Text Box 35"/>
              <p:cNvSpPr txBox="1">
                <a:spLocks noChangeArrowheads="1"/>
              </p:cNvSpPr>
              <p:nvPr/>
            </p:nvSpPr>
            <p:spPr bwMode="auto">
              <a:xfrm>
                <a:off x="8267153" y="908162"/>
                <a:ext cx="361950" cy="2746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/>
                  <a:t>bc</a:t>
                </a:r>
              </a:p>
            </p:txBody>
          </p:sp>
          <p:sp>
            <p:nvSpPr>
              <p:cNvPr id="20" name="Text Box 36"/>
              <p:cNvSpPr txBox="1">
                <a:spLocks noChangeArrowheads="1"/>
              </p:cNvSpPr>
              <p:nvPr/>
            </p:nvSpPr>
            <p:spPr bwMode="auto">
              <a:xfrm>
                <a:off x="8684666" y="525575"/>
                <a:ext cx="268287" cy="2746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altLang="en-US" sz="1200" b="1"/>
                  <a:t>a</a:t>
                </a:r>
              </a:p>
            </p:txBody>
          </p:sp>
        </p:grpSp>
        <p:graphicFrame>
          <p:nvGraphicFramePr>
            <p:cNvPr id="6" name="Object 3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46597277"/>
                </p:ext>
              </p:extLst>
            </p:nvPr>
          </p:nvGraphicFramePr>
          <p:xfrm>
            <a:off x="50800" y="3479800"/>
            <a:ext cx="4479925" cy="33178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Object 3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49193214"/>
                </p:ext>
              </p:extLst>
            </p:nvPr>
          </p:nvGraphicFramePr>
          <p:xfrm>
            <a:off x="4622800" y="3470275"/>
            <a:ext cx="4460875" cy="3327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8" name="TextBox 7"/>
            <p:cNvSpPr txBox="1"/>
            <p:nvPr/>
          </p:nvSpPr>
          <p:spPr>
            <a:xfrm>
              <a:off x="0" y="-21815"/>
              <a:ext cx="38023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/>
                <a:t>a.</a:t>
              </a:r>
              <a:endParaRPr lang="en-US" sz="2000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0" y="3411506"/>
              <a:ext cx="39145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/>
                <a:t>b.</a:t>
              </a:r>
              <a:endParaRPr lang="en-US" sz="2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62828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37</Words>
  <Application>Microsoft Office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 Larry A COGBURN</dc:creator>
  <cp:lastModifiedBy>Dr. Larry A COGBURN</cp:lastModifiedBy>
  <cp:revision>3</cp:revision>
  <cp:lastPrinted>2018-09-18T17:12:22Z</cp:lastPrinted>
  <dcterms:created xsi:type="dcterms:W3CDTF">2018-09-18T17:09:15Z</dcterms:created>
  <dcterms:modified xsi:type="dcterms:W3CDTF">2019-12-30T22:31:32Z</dcterms:modified>
</cp:coreProperties>
</file>